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4679950" cy="1800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251" d="100"/>
          <a:sy n="251" d="100"/>
        </p:scale>
        <p:origin x="158" y="30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4994" y="294620"/>
            <a:ext cx="3509963" cy="626745"/>
          </a:xfrm>
        </p:spPr>
        <p:txBody>
          <a:bodyPr anchor="b"/>
          <a:lstStyle>
            <a:lvl1pPr algn="ctr">
              <a:defRPr sz="157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4994" y="945535"/>
            <a:ext cx="3509963" cy="434638"/>
          </a:xfrm>
        </p:spPr>
        <p:txBody>
          <a:bodyPr/>
          <a:lstStyle>
            <a:lvl1pPr marL="0" indent="0" algn="ctr">
              <a:buNone/>
              <a:defRPr sz="630"/>
            </a:lvl1pPr>
            <a:lvl2pPr marL="120015" indent="0" algn="ctr">
              <a:buNone/>
              <a:defRPr sz="525"/>
            </a:lvl2pPr>
            <a:lvl3pPr marL="240030" indent="0" algn="ctr">
              <a:buNone/>
              <a:defRPr sz="472"/>
            </a:lvl3pPr>
            <a:lvl4pPr marL="360045" indent="0" algn="ctr">
              <a:buNone/>
              <a:defRPr sz="420"/>
            </a:lvl4pPr>
            <a:lvl5pPr marL="480060" indent="0" algn="ctr">
              <a:buNone/>
              <a:defRPr sz="420"/>
            </a:lvl5pPr>
            <a:lvl6pPr marL="600075" indent="0" algn="ctr">
              <a:buNone/>
              <a:defRPr sz="420"/>
            </a:lvl6pPr>
            <a:lvl7pPr marL="720090" indent="0" algn="ctr">
              <a:buNone/>
              <a:defRPr sz="420"/>
            </a:lvl7pPr>
            <a:lvl8pPr marL="840105" indent="0" algn="ctr">
              <a:buNone/>
              <a:defRPr sz="420"/>
            </a:lvl8pPr>
            <a:lvl9pPr marL="960120" indent="0" algn="ctr">
              <a:buNone/>
              <a:defRPr sz="4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5661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7395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49089" y="95846"/>
            <a:ext cx="1009114" cy="152560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1747" y="95846"/>
            <a:ext cx="2968843" cy="152560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0800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850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9309" y="448807"/>
            <a:ext cx="4036457" cy="748843"/>
          </a:xfrm>
        </p:spPr>
        <p:txBody>
          <a:bodyPr anchor="b"/>
          <a:lstStyle>
            <a:lvl1pPr>
              <a:defRPr sz="157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9309" y="1204734"/>
            <a:ext cx="4036457" cy="393799"/>
          </a:xfrm>
        </p:spPr>
        <p:txBody>
          <a:bodyPr/>
          <a:lstStyle>
            <a:lvl1pPr marL="0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1pPr>
            <a:lvl2pPr marL="120015" indent="0">
              <a:buNone/>
              <a:defRPr sz="525">
                <a:solidFill>
                  <a:schemeClr val="tx1">
                    <a:tint val="75000"/>
                  </a:schemeClr>
                </a:solidFill>
              </a:defRPr>
            </a:lvl2pPr>
            <a:lvl3pPr marL="240030" indent="0">
              <a:buNone/>
              <a:defRPr sz="472">
                <a:solidFill>
                  <a:schemeClr val="tx1">
                    <a:tint val="75000"/>
                  </a:schemeClr>
                </a:solidFill>
              </a:defRPr>
            </a:lvl3pPr>
            <a:lvl4pPr marL="36004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4pPr>
            <a:lvl5pPr marL="48006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5pPr>
            <a:lvl6pPr marL="60007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6pPr>
            <a:lvl7pPr marL="72009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7pPr>
            <a:lvl8pPr marL="84010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8pPr>
            <a:lvl9pPr marL="96012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843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1746" y="479227"/>
            <a:ext cx="1988979" cy="114222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69225" y="479227"/>
            <a:ext cx="1988979" cy="114222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034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95846"/>
            <a:ext cx="4036457" cy="34796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2356" y="441305"/>
            <a:ext cx="1979838" cy="216277"/>
          </a:xfrm>
        </p:spPr>
        <p:txBody>
          <a:bodyPr anchor="b"/>
          <a:lstStyle>
            <a:lvl1pPr marL="0" indent="0">
              <a:buNone/>
              <a:defRPr sz="630" b="1"/>
            </a:lvl1pPr>
            <a:lvl2pPr marL="120015" indent="0">
              <a:buNone/>
              <a:defRPr sz="525" b="1"/>
            </a:lvl2pPr>
            <a:lvl3pPr marL="240030" indent="0">
              <a:buNone/>
              <a:defRPr sz="472" b="1"/>
            </a:lvl3pPr>
            <a:lvl4pPr marL="360045" indent="0">
              <a:buNone/>
              <a:defRPr sz="420" b="1"/>
            </a:lvl4pPr>
            <a:lvl5pPr marL="480060" indent="0">
              <a:buNone/>
              <a:defRPr sz="420" b="1"/>
            </a:lvl5pPr>
            <a:lvl6pPr marL="600075" indent="0">
              <a:buNone/>
              <a:defRPr sz="420" b="1"/>
            </a:lvl6pPr>
            <a:lvl7pPr marL="720090" indent="0">
              <a:buNone/>
              <a:defRPr sz="420" b="1"/>
            </a:lvl7pPr>
            <a:lvl8pPr marL="840105" indent="0">
              <a:buNone/>
              <a:defRPr sz="420" b="1"/>
            </a:lvl8pPr>
            <a:lvl9pPr marL="960120" indent="0">
              <a:buNone/>
              <a:defRPr sz="4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2356" y="657582"/>
            <a:ext cx="1979838" cy="9672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69225" y="441305"/>
            <a:ext cx="1989588" cy="216277"/>
          </a:xfrm>
        </p:spPr>
        <p:txBody>
          <a:bodyPr anchor="b"/>
          <a:lstStyle>
            <a:lvl1pPr marL="0" indent="0">
              <a:buNone/>
              <a:defRPr sz="630" b="1"/>
            </a:lvl1pPr>
            <a:lvl2pPr marL="120015" indent="0">
              <a:buNone/>
              <a:defRPr sz="525" b="1"/>
            </a:lvl2pPr>
            <a:lvl3pPr marL="240030" indent="0">
              <a:buNone/>
              <a:defRPr sz="472" b="1"/>
            </a:lvl3pPr>
            <a:lvl4pPr marL="360045" indent="0">
              <a:buNone/>
              <a:defRPr sz="420" b="1"/>
            </a:lvl4pPr>
            <a:lvl5pPr marL="480060" indent="0">
              <a:buNone/>
              <a:defRPr sz="420" b="1"/>
            </a:lvl5pPr>
            <a:lvl6pPr marL="600075" indent="0">
              <a:buNone/>
              <a:defRPr sz="420" b="1"/>
            </a:lvl6pPr>
            <a:lvl7pPr marL="720090" indent="0">
              <a:buNone/>
              <a:defRPr sz="420" b="1"/>
            </a:lvl7pPr>
            <a:lvl8pPr marL="840105" indent="0">
              <a:buNone/>
              <a:defRPr sz="420" b="1"/>
            </a:lvl8pPr>
            <a:lvl9pPr marL="960120" indent="0">
              <a:buNone/>
              <a:defRPr sz="4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69225" y="657582"/>
            <a:ext cx="1989588" cy="9672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5579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1170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5751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120015"/>
            <a:ext cx="1509406" cy="420053"/>
          </a:xfrm>
        </p:spPr>
        <p:txBody>
          <a:bodyPr anchor="b"/>
          <a:lstStyle>
            <a:lvl1pPr>
              <a:defRPr sz="84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89588" y="259199"/>
            <a:ext cx="2369225" cy="1279327"/>
          </a:xfrm>
        </p:spPr>
        <p:txBody>
          <a:bodyPr/>
          <a:lstStyle>
            <a:lvl1pPr>
              <a:defRPr sz="840"/>
            </a:lvl1pPr>
            <a:lvl2pPr>
              <a:defRPr sz="735"/>
            </a:lvl2pPr>
            <a:lvl3pPr>
              <a:defRPr sz="630"/>
            </a:lvl3pPr>
            <a:lvl4pPr>
              <a:defRPr sz="525"/>
            </a:lvl4pPr>
            <a:lvl5pPr>
              <a:defRPr sz="525"/>
            </a:lvl5pPr>
            <a:lvl6pPr>
              <a:defRPr sz="525"/>
            </a:lvl6pPr>
            <a:lvl7pPr>
              <a:defRPr sz="525"/>
            </a:lvl7pPr>
            <a:lvl8pPr>
              <a:defRPr sz="525"/>
            </a:lvl8pPr>
            <a:lvl9pPr>
              <a:defRPr sz="5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540067"/>
            <a:ext cx="1509406" cy="1000542"/>
          </a:xfrm>
        </p:spPr>
        <p:txBody>
          <a:bodyPr/>
          <a:lstStyle>
            <a:lvl1pPr marL="0" indent="0">
              <a:buNone/>
              <a:defRPr sz="420"/>
            </a:lvl1pPr>
            <a:lvl2pPr marL="120015" indent="0">
              <a:buNone/>
              <a:defRPr sz="368"/>
            </a:lvl2pPr>
            <a:lvl3pPr marL="240030" indent="0">
              <a:buNone/>
              <a:defRPr sz="315"/>
            </a:lvl3pPr>
            <a:lvl4pPr marL="360045" indent="0">
              <a:buNone/>
              <a:defRPr sz="263"/>
            </a:lvl4pPr>
            <a:lvl5pPr marL="480060" indent="0">
              <a:buNone/>
              <a:defRPr sz="263"/>
            </a:lvl5pPr>
            <a:lvl6pPr marL="600075" indent="0">
              <a:buNone/>
              <a:defRPr sz="263"/>
            </a:lvl6pPr>
            <a:lvl7pPr marL="720090" indent="0">
              <a:buNone/>
              <a:defRPr sz="263"/>
            </a:lvl7pPr>
            <a:lvl8pPr marL="840105" indent="0">
              <a:buNone/>
              <a:defRPr sz="263"/>
            </a:lvl8pPr>
            <a:lvl9pPr marL="960120" indent="0">
              <a:buNone/>
              <a:defRPr sz="26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0319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120015"/>
            <a:ext cx="1509406" cy="420053"/>
          </a:xfrm>
        </p:spPr>
        <p:txBody>
          <a:bodyPr anchor="b"/>
          <a:lstStyle>
            <a:lvl1pPr>
              <a:defRPr sz="84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89588" y="259199"/>
            <a:ext cx="2369225" cy="1279327"/>
          </a:xfrm>
        </p:spPr>
        <p:txBody>
          <a:bodyPr anchor="t"/>
          <a:lstStyle>
            <a:lvl1pPr marL="0" indent="0">
              <a:buNone/>
              <a:defRPr sz="840"/>
            </a:lvl1pPr>
            <a:lvl2pPr marL="120015" indent="0">
              <a:buNone/>
              <a:defRPr sz="735"/>
            </a:lvl2pPr>
            <a:lvl3pPr marL="240030" indent="0">
              <a:buNone/>
              <a:defRPr sz="630"/>
            </a:lvl3pPr>
            <a:lvl4pPr marL="360045" indent="0">
              <a:buNone/>
              <a:defRPr sz="525"/>
            </a:lvl4pPr>
            <a:lvl5pPr marL="480060" indent="0">
              <a:buNone/>
              <a:defRPr sz="525"/>
            </a:lvl5pPr>
            <a:lvl6pPr marL="600075" indent="0">
              <a:buNone/>
              <a:defRPr sz="525"/>
            </a:lvl6pPr>
            <a:lvl7pPr marL="720090" indent="0">
              <a:buNone/>
              <a:defRPr sz="525"/>
            </a:lvl7pPr>
            <a:lvl8pPr marL="840105" indent="0">
              <a:buNone/>
              <a:defRPr sz="525"/>
            </a:lvl8pPr>
            <a:lvl9pPr marL="960120" indent="0">
              <a:buNone/>
              <a:defRPr sz="52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540067"/>
            <a:ext cx="1509406" cy="1000542"/>
          </a:xfrm>
        </p:spPr>
        <p:txBody>
          <a:bodyPr/>
          <a:lstStyle>
            <a:lvl1pPr marL="0" indent="0">
              <a:buNone/>
              <a:defRPr sz="420"/>
            </a:lvl1pPr>
            <a:lvl2pPr marL="120015" indent="0">
              <a:buNone/>
              <a:defRPr sz="368"/>
            </a:lvl2pPr>
            <a:lvl3pPr marL="240030" indent="0">
              <a:buNone/>
              <a:defRPr sz="315"/>
            </a:lvl3pPr>
            <a:lvl4pPr marL="360045" indent="0">
              <a:buNone/>
              <a:defRPr sz="263"/>
            </a:lvl4pPr>
            <a:lvl5pPr marL="480060" indent="0">
              <a:buNone/>
              <a:defRPr sz="263"/>
            </a:lvl5pPr>
            <a:lvl6pPr marL="600075" indent="0">
              <a:buNone/>
              <a:defRPr sz="263"/>
            </a:lvl6pPr>
            <a:lvl7pPr marL="720090" indent="0">
              <a:buNone/>
              <a:defRPr sz="263"/>
            </a:lvl7pPr>
            <a:lvl8pPr marL="840105" indent="0">
              <a:buNone/>
              <a:defRPr sz="263"/>
            </a:lvl8pPr>
            <a:lvl9pPr marL="960120" indent="0">
              <a:buNone/>
              <a:defRPr sz="26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599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1747" y="95846"/>
            <a:ext cx="4036457" cy="3479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1747" y="479227"/>
            <a:ext cx="4036457" cy="11422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1746" y="1668542"/>
            <a:ext cx="1052989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0661A-DDA9-4FA3-A781-410C940A4930}" type="datetimeFigureOut">
              <a:rPr kumimoji="1" lang="ja-JP" altLang="en-US" smtClean="0"/>
              <a:t>2025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50234" y="1668542"/>
            <a:ext cx="1579483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305215" y="1668542"/>
            <a:ext cx="1052989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04D5E-F58B-4AFA-9E69-8D4623CAA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0159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40030" rtl="0" eaLnBrk="1" latinLnBrk="0" hangingPunct="1">
        <a:lnSpc>
          <a:spcPct val="90000"/>
        </a:lnSpc>
        <a:spcBef>
          <a:spcPct val="0"/>
        </a:spcBef>
        <a:buNone/>
        <a:defRPr kumimoji="1" sz="11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008" indent="-60008" algn="l" defTabSz="24003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kumimoji="1" sz="735" kern="1200">
          <a:solidFill>
            <a:schemeClr val="tx1"/>
          </a:solidFill>
          <a:latin typeface="+mn-lt"/>
          <a:ea typeface="+mn-ea"/>
          <a:cs typeface="+mn-cs"/>
        </a:defRPr>
      </a:lvl1pPr>
      <a:lvl2pPr marL="18002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kumimoji="1" sz="630" kern="1200">
          <a:solidFill>
            <a:schemeClr val="tx1"/>
          </a:solidFill>
          <a:latin typeface="+mn-lt"/>
          <a:ea typeface="+mn-ea"/>
          <a:cs typeface="+mn-cs"/>
        </a:defRPr>
      </a:lvl2pPr>
      <a:lvl3pPr marL="30003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kumimoji="1" sz="525" kern="1200">
          <a:solidFill>
            <a:schemeClr val="tx1"/>
          </a:solidFill>
          <a:latin typeface="+mn-lt"/>
          <a:ea typeface="+mn-ea"/>
          <a:cs typeface="+mn-cs"/>
        </a:defRPr>
      </a:lvl3pPr>
      <a:lvl4pPr marL="42005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4pPr>
      <a:lvl5pPr marL="54006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5pPr>
      <a:lvl6pPr marL="66008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6pPr>
      <a:lvl7pPr marL="78009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7pPr>
      <a:lvl8pPr marL="90011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8pPr>
      <a:lvl9pPr marL="102012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1pPr>
      <a:lvl2pPr marL="120015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2pPr>
      <a:lvl3pPr marL="240030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3pPr>
      <a:lvl4pPr marL="360045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4pPr>
      <a:lvl5pPr marL="480060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5pPr>
      <a:lvl6pPr marL="600075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6pPr>
      <a:lvl7pPr marL="720090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7pPr>
      <a:lvl8pPr marL="840105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8pPr>
      <a:lvl9pPr marL="960120" algn="l" defTabSz="240030" rtl="0" eaLnBrk="1" latinLnBrk="0" hangingPunct="1">
        <a:defRPr kumimoji="1" sz="4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F08AB05-25D7-7246-015C-DDBC14CA721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F640099-CA03-EA0C-90AC-87A4F5E38B0F}"/>
              </a:ext>
            </a:extLst>
          </p:cNvPr>
          <p:cNvSpPr txBox="1"/>
          <p:nvPr/>
        </p:nvSpPr>
        <p:spPr>
          <a:xfrm>
            <a:off x="144950" y="359871"/>
            <a:ext cx="98832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i="0" dirty="0">
                <a:solidFill>
                  <a:srgbClr val="1F1F1F"/>
                </a:solidFill>
                <a:effectLst/>
                <a:latin typeface="Arial" panose="020B0604020202020204" pitchFamily="34" charset="0"/>
              </a:rPr>
              <a:t>Dried fibroblast sheet</a:t>
            </a:r>
            <a:endParaRPr lang="ja-JP" altLang="en-US" sz="600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357053C-0E2E-331D-E186-54FA5FBD59CC}"/>
              </a:ext>
            </a:extLst>
          </p:cNvPr>
          <p:cNvSpPr txBox="1"/>
          <p:nvPr/>
        </p:nvSpPr>
        <p:spPr>
          <a:xfrm>
            <a:off x="108844" y="1578978"/>
            <a:ext cx="128518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i="0" dirty="0">
                <a:effectLst/>
                <a:latin typeface="Arial" panose="020B0604020202020204" pitchFamily="34" charset="0"/>
              </a:rPr>
              <a:t>Esophageal anastomosis</a:t>
            </a:r>
            <a:endParaRPr lang="ja-JP" altLang="en-US" sz="600" b="1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4B66374-4BF4-112B-4AF8-F854D176AB17}"/>
              </a:ext>
            </a:extLst>
          </p:cNvPr>
          <p:cNvSpPr txBox="1"/>
          <p:nvPr/>
        </p:nvSpPr>
        <p:spPr>
          <a:xfrm>
            <a:off x="3186469" y="1578978"/>
            <a:ext cx="142502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Pressure resistance Assessment</a:t>
            </a:r>
            <a:endParaRPr lang="ja-JP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23CC67A-1D29-E115-6E73-FE7BDA720A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51" y="920107"/>
            <a:ext cx="724606" cy="71007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D3E4584D-6D7F-19E0-C04D-24E526ADA8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5725" y="910620"/>
            <a:ext cx="387318" cy="732073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99B55D2F-50EA-FD67-764D-075AB184B3B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35927" y="712909"/>
            <a:ext cx="897239" cy="897239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35E2C8A7-3218-8E39-7FF7-53851DF6011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1018" y="498758"/>
            <a:ext cx="364484" cy="233820"/>
          </a:xfrm>
          <a:prstGeom prst="rect">
            <a:avLst/>
          </a:prstGeom>
        </p:spPr>
      </p:pic>
      <p:sp>
        <p:nvSpPr>
          <p:cNvPr id="14" name="矢印: 右 13">
            <a:extLst>
              <a:ext uri="{FF2B5EF4-FFF2-40B4-BE49-F238E27FC236}">
                <a16:creationId xmlns:a16="http://schemas.microsoft.com/office/drawing/2014/main" id="{3730F237-7EF1-FE89-301A-96DF64B31009}"/>
              </a:ext>
            </a:extLst>
          </p:cNvPr>
          <p:cNvSpPr/>
          <p:nvPr/>
        </p:nvSpPr>
        <p:spPr>
          <a:xfrm>
            <a:off x="551930" y="1155609"/>
            <a:ext cx="174371" cy="222394"/>
          </a:xfrm>
          <a:prstGeom prst="rightArrow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矢印: 右 15">
            <a:extLst>
              <a:ext uri="{FF2B5EF4-FFF2-40B4-BE49-F238E27FC236}">
                <a16:creationId xmlns:a16="http://schemas.microsoft.com/office/drawing/2014/main" id="{8D2134A5-7635-9713-0C5B-D32EB7649618}"/>
              </a:ext>
            </a:extLst>
          </p:cNvPr>
          <p:cNvSpPr/>
          <p:nvPr/>
        </p:nvSpPr>
        <p:spPr>
          <a:xfrm>
            <a:off x="1327438" y="1155609"/>
            <a:ext cx="174371" cy="222394"/>
          </a:xfrm>
          <a:prstGeom prst="rightArrow">
            <a:avLst/>
          </a:prstGeom>
          <a:solidFill>
            <a:srgbClr val="FFFF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7E639AC-4B64-12CD-0E06-88D9E9DAF6D8}"/>
              </a:ext>
            </a:extLst>
          </p:cNvPr>
          <p:cNvSpPr txBox="1"/>
          <p:nvPr/>
        </p:nvSpPr>
        <p:spPr>
          <a:xfrm>
            <a:off x="3683170" y="442852"/>
            <a:ext cx="8868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ontrol: 80 mmHg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24C5DEC-A309-F34D-05F1-09BBCC0B1B1D}"/>
              </a:ext>
            </a:extLst>
          </p:cNvPr>
          <p:cNvSpPr txBox="1"/>
          <p:nvPr/>
        </p:nvSpPr>
        <p:spPr>
          <a:xfrm>
            <a:off x="3172034" y="557003"/>
            <a:ext cx="142502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i="0" dirty="0">
                <a:solidFill>
                  <a:srgbClr val="1F1F1F"/>
                </a:solidFill>
                <a:effectLst/>
                <a:latin typeface="Arial" panose="020B0604020202020204" pitchFamily="34" charset="0"/>
              </a:rPr>
              <a:t>Dried fibroblast sheet</a:t>
            </a:r>
            <a:r>
              <a:rPr lang="en-US" altLang="ja-JP" sz="600" b="1" i="0" dirty="0">
                <a:effectLst/>
                <a:latin typeface="Arial" panose="020B0604020202020204" pitchFamily="34" charset="0"/>
              </a:rPr>
              <a:t>:</a:t>
            </a:r>
            <a:r>
              <a:rPr lang="en-US" altLang="ja-JP" sz="600" b="1" i="0" dirty="0">
                <a:solidFill>
                  <a:srgbClr val="1F1F1F"/>
                </a:solidFill>
                <a:effectLst/>
                <a:latin typeface="Arial" panose="020B0604020202020204" pitchFamily="34" charset="0"/>
              </a:rPr>
              <a:t> 120 mmHg</a:t>
            </a:r>
            <a:endParaRPr lang="ja-JP" altLang="en-US" sz="600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354A333-A693-062F-628E-AAABB59D706C}"/>
              </a:ext>
            </a:extLst>
          </p:cNvPr>
          <p:cNvSpPr txBox="1"/>
          <p:nvPr/>
        </p:nvSpPr>
        <p:spPr>
          <a:xfrm>
            <a:off x="1953059" y="635244"/>
            <a:ext cx="97587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Anastomotic leakage</a:t>
            </a:r>
          </a:p>
        </p:txBody>
      </p:sp>
      <p:sp>
        <p:nvSpPr>
          <p:cNvPr id="26" name="矢印: 下 25">
            <a:extLst>
              <a:ext uri="{FF2B5EF4-FFF2-40B4-BE49-F238E27FC236}">
                <a16:creationId xmlns:a16="http://schemas.microsoft.com/office/drawing/2014/main" id="{3F943482-71B5-28BD-CA15-D5DEA7E402F5}"/>
              </a:ext>
            </a:extLst>
          </p:cNvPr>
          <p:cNvSpPr/>
          <p:nvPr/>
        </p:nvSpPr>
        <p:spPr>
          <a:xfrm>
            <a:off x="1909357" y="677221"/>
            <a:ext cx="90922" cy="128896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12F25C5-7F68-1B88-DFBF-DFFB6AD49002}"/>
              </a:ext>
            </a:extLst>
          </p:cNvPr>
          <p:cNvSpPr txBox="1"/>
          <p:nvPr/>
        </p:nvSpPr>
        <p:spPr>
          <a:xfrm>
            <a:off x="1953059" y="466485"/>
            <a:ext cx="83902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Type I collagen</a:t>
            </a:r>
            <a:r>
              <a:rPr lang="ja-JP" alt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D2D5910-5B33-C6D0-CA14-B50218E25E75}"/>
              </a:ext>
            </a:extLst>
          </p:cNvPr>
          <p:cNvSpPr txBox="1"/>
          <p:nvPr/>
        </p:nvSpPr>
        <p:spPr>
          <a:xfrm>
            <a:off x="-2525" y="661099"/>
            <a:ext cx="13299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Release of multiple factors: </a:t>
            </a:r>
          </a:p>
          <a:p>
            <a:r>
              <a:rPr lang="en-US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HGF, VEGF, FGF2, HMGB1, etc. </a:t>
            </a:r>
            <a:endParaRPr lang="ja-JP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矢印: 下 8">
            <a:extLst>
              <a:ext uri="{FF2B5EF4-FFF2-40B4-BE49-F238E27FC236}">
                <a16:creationId xmlns:a16="http://schemas.microsoft.com/office/drawing/2014/main" id="{32E2A1C3-68EB-B4F7-0A3A-ECD36544E6D7}"/>
              </a:ext>
            </a:extLst>
          </p:cNvPr>
          <p:cNvSpPr/>
          <p:nvPr/>
        </p:nvSpPr>
        <p:spPr>
          <a:xfrm flipV="1">
            <a:off x="1909357" y="476505"/>
            <a:ext cx="90922" cy="128896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BA48BF0-85DE-8C66-042A-05BF9D4289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13490" y="951422"/>
            <a:ext cx="310021" cy="658063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2D3A97A-7E15-C8FD-8343-E9921FE6BDE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07710" y="951422"/>
            <a:ext cx="310021" cy="658063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54E5487-1705-0E3A-6B65-81A323832112}"/>
              </a:ext>
            </a:extLst>
          </p:cNvPr>
          <p:cNvSpPr txBox="1"/>
          <p:nvPr/>
        </p:nvSpPr>
        <p:spPr>
          <a:xfrm>
            <a:off x="2529869" y="800151"/>
            <a:ext cx="4656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00F8992-1D85-8A51-1801-3AAE0850A45B}"/>
              </a:ext>
            </a:extLst>
          </p:cNvPr>
          <p:cNvSpPr txBox="1"/>
          <p:nvPr/>
        </p:nvSpPr>
        <p:spPr>
          <a:xfrm>
            <a:off x="1518617" y="800151"/>
            <a:ext cx="97587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i="0" dirty="0">
                <a:solidFill>
                  <a:srgbClr val="1F1F1F"/>
                </a:solidFill>
                <a:effectLst/>
                <a:latin typeface="Arial" panose="020B0604020202020204" pitchFamily="34" charset="0"/>
              </a:rPr>
              <a:t>Dried fibroblast sheet</a:t>
            </a:r>
            <a:endParaRPr lang="ja-JP" altLang="en-US" sz="600" b="1" dirty="0"/>
          </a:p>
        </p:txBody>
      </p:sp>
      <p:sp>
        <p:nvSpPr>
          <p:cNvPr id="11" name="四角形: 角を丸くする 10">
            <a:extLst>
              <a:ext uri="{FF2B5EF4-FFF2-40B4-BE49-F238E27FC236}">
                <a16:creationId xmlns:a16="http://schemas.microsoft.com/office/drawing/2014/main" id="{BD83FB06-9F33-1A0A-CB8E-837D4DA8B9AD}"/>
              </a:ext>
            </a:extLst>
          </p:cNvPr>
          <p:cNvSpPr/>
          <p:nvPr/>
        </p:nvSpPr>
        <p:spPr>
          <a:xfrm>
            <a:off x="1553666" y="452433"/>
            <a:ext cx="1498961" cy="1306496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四角形: 角を丸くする 17">
            <a:extLst>
              <a:ext uri="{FF2B5EF4-FFF2-40B4-BE49-F238E27FC236}">
                <a16:creationId xmlns:a16="http://schemas.microsoft.com/office/drawing/2014/main" id="{D5EE163A-0FB2-22A9-29BC-64A2C8BBA7A8}"/>
              </a:ext>
            </a:extLst>
          </p:cNvPr>
          <p:cNvSpPr/>
          <p:nvPr/>
        </p:nvSpPr>
        <p:spPr>
          <a:xfrm>
            <a:off x="3100143" y="447221"/>
            <a:ext cx="1543351" cy="1306496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0AEAC64-171F-BCE9-1458-BDFBBFFE066F}"/>
              </a:ext>
            </a:extLst>
          </p:cNvPr>
          <p:cNvSpPr txBox="1"/>
          <p:nvPr/>
        </p:nvSpPr>
        <p:spPr>
          <a:xfrm>
            <a:off x="1858528" y="1578978"/>
            <a:ext cx="100740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00" b="1" dirty="0">
                <a:latin typeface="Arial" panose="020B0604020202020204" pitchFamily="34" charset="0"/>
                <a:cs typeface="Arial" panose="020B0604020202020204" pitchFamily="34" charset="0"/>
              </a:rPr>
              <a:t>Abscess Assessment</a:t>
            </a:r>
            <a:endParaRPr lang="ja-JP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6FA1E57-511E-FE30-0E47-3F59BE307581}"/>
              </a:ext>
            </a:extLst>
          </p:cNvPr>
          <p:cNvSpPr txBox="1"/>
          <p:nvPr/>
        </p:nvSpPr>
        <p:spPr>
          <a:xfrm>
            <a:off x="34751" y="64040"/>
            <a:ext cx="4608743" cy="2308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llogeneic dry-preserved fibroblast sheets reduced the anastomotic leakage incidence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四角形: 角を丸くする 28">
            <a:extLst>
              <a:ext uri="{FF2B5EF4-FFF2-40B4-BE49-F238E27FC236}">
                <a16:creationId xmlns:a16="http://schemas.microsoft.com/office/drawing/2014/main" id="{6FF1F020-0E45-C202-A985-A665AF653845}"/>
              </a:ext>
            </a:extLst>
          </p:cNvPr>
          <p:cNvSpPr/>
          <p:nvPr/>
        </p:nvSpPr>
        <p:spPr>
          <a:xfrm>
            <a:off x="38695" y="364815"/>
            <a:ext cx="1236941" cy="1388902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1405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7</TotalTime>
  <Words>53</Words>
  <Application>Microsoft Office PowerPoint</Application>
  <PresentationFormat>ユーザー設定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耕司 上野</dc:creator>
  <cp:lastModifiedBy>耕司 上野</cp:lastModifiedBy>
  <cp:revision>23</cp:revision>
  <dcterms:created xsi:type="dcterms:W3CDTF">2025-04-22T07:41:07Z</dcterms:created>
  <dcterms:modified xsi:type="dcterms:W3CDTF">2025-05-29T06:54:27Z</dcterms:modified>
</cp:coreProperties>
</file>